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E5A2CD41-7473-4386-925B-D61CE55522E4}"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677E35D-323E-493E-A20D-29F19796F47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56EAD53-6C64-487B-AE88-D2789E4ED593}"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CBA9E3E9-9CD8-4AFF-928D-F4FFDAF9C31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C7DF3D8-F089-4DAB-919D-DF38175B406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3D51C8F-DE62-4635-9E4E-DFFB1B98388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977C311-1F14-4449-928D-1000C7454D5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1574878-A42F-47BE-BECE-5292D606590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114CA52-D99E-4FA6-AB89-248330BA517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E61F66D-79F7-4738-B839-504ACC5FD0B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6FC31F8-4E63-4AA8-88EE-C4C6EF07EEF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989B2C0-FE22-4DEF-BB99-B3D72DFF3414}"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56998FD-DEF5-4F9B-8381-BE147F1A2816}" type="slidenum">
              <a:rPr b="0" lang="zh-CN"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图片 1" descr=""/>
          <p:cNvPicPr/>
          <p:nvPr/>
        </p:nvPicPr>
        <p:blipFill>
          <a:blip r:embed="rId1"/>
          <a:stretch/>
        </p:blipFill>
        <p:spPr>
          <a:xfrm>
            <a:off x="1189080" y="44280"/>
            <a:ext cx="6554880" cy="6026400"/>
          </a:xfrm>
          <a:prstGeom prst="rect">
            <a:avLst/>
          </a:prstGeom>
          <a:ln w="0">
            <a:noFill/>
          </a:ln>
        </p:spPr>
      </p:pic>
      <p:sp>
        <p:nvSpPr>
          <p:cNvPr id="42" name="文本框 99"/>
          <p:cNvSpPr/>
          <p:nvPr/>
        </p:nvSpPr>
        <p:spPr>
          <a:xfrm>
            <a:off x="685800" y="6021360"/>
            <a:ext cx="8077320" cy="8240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rPr>
              <a:t>Figure S1. (A) Rarefaction curve analysis of archaeal 16S rRNA gene clone libraries. (B) Rank abundance curves of archaeal 16S rRNA gene clone libraries. Sample color codes are presented in the legend.</a:t>
            </a:r>
            <a:endParaRPr b="0" lang="en-US" sz="16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3" name="图片 1" descr=""/>
          <p:cNvPicPr/>
          <p:nvPr/>
        </p:nvPicPr>
        <p:blipFill>
          <a:blip r:embed="rId1"/>
          <a:stretch/>
        </p:blipFill>
        <p:spPr>
          <a:xfrm>
            <a:off x="971640" y="-27000"/>
            <a:ext cx="6926040" cy="5834160"/>
          </a:xfrm>
          <a:prstGeom prst="rect">
            <a:avLst/>
          </a:prstGeom>
          <a:ln w="0">
            <a:noFill/>
          </a:ln>
        </p:spPr>
      </p:pic>
      <p:sp>
        <p:nvSpPr>
          <p:cNvPr id="44" name="文本框 99"/>
          <p:cNvSpPr/>
          <p:nvPr/>
        </p:nvSpPr>
        <p:spPr>
          <a:xfrm>
            <a:off x="473040" y="5791320"/>
            <a:ext cx="8217000" cy="10674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rPr>
              <a:t>Figure S2. Microbial composition and abundance at phylum level (A) and genus level (B) for gut microbiota in SZ (Case) and NC (Control) groups. The bars represent the average relative abundance of each genera, having significant differences between the two groups, with 95% confidence interval distribution and </a:t>
            </a:r>
            <a:r>
              <a:rPr b="0" i="1" lang="en-US" sz="1600" spc="-1" strike="noStrike">
                <a:solidFill>
                  <a:srgbClr val="000000"/>
                </a:solidFill>
                <a:latin typeface="Times New Roman"/>
              </a:rPr>
              <a:t>p</a:t>
            </a:r>
            <a:r>
              <a:rPr b="0" lang="en-US" sz="1600" spc="-1" strike="noStrike">
                <a:solidFill>
                  <a:srgbClr val="000000"/>
                </a:solidFill>
                <a:latin typeface="Times New Roman"/>
              </a:rPr>
              <a:t> value shown on their right.</a:t>
            </a:r>
            <a:endParaRPr b="0" lang="en-US" sz="16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2-09-04T03:03:38Z</dcterms:created>
  <dc:creator>Administrator</dc:creator>
  <dc:description/>
  <dc:language>en-US</dc:language>
  <cp:lastModifiedBy>Ggg</cp:lastModifiedBy>
  <dcterms:modified xsi:type="dcterms:W3CDTF">2022-09-04T03:03:38Z</dcterms:modified>
  <cp:revision>1</cp:revision>
  <dc:subject/>
  <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AD71067AFC79476C906D75262AFC2524</vt:lpwstr>
  </property>
  <property fmtid="{D5CDD505-2E9C-101B-9397-08002B2CF9AE}" pid="3" name="KSOProductBuildVer">
    <vt:lpwstr>2052-11.1.0.12313</vt:lpwstr>
  </property>
</Properties>
</file>